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325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&#233;sultats%20M&#233;lanie\article%20in%20vivo%20M&#233;lanie\fichiers%20pour%20soumettre\fichiers%20donn&#233;es\Cholesterolemia%200808201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788321518106685"/>
          <c:y val="2.2937883445049316E-2"/>
          <c:w val="0.76560269651060975"/>
          <c:h val="0.9171161537606932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euil1!$F$9</c:f>
              <c:strCache>
                <c:ptCount val="1"/>
                <c:pt idx="0">
                  <c:v>OLE die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Feuil1!$H$9;Feuil1!$J$9)</c:f>
                <c:numCache>
                  <c:formatCode>General</c:formatCode>
                  <c:ptCount val="2"/>
                  <c:pt idx="0">
                    <c:v>5.4360457946143512E-2</c:v>
                  </c:pt>
                  <c:pt idx="1">
                    <c:v>4.2853998511138996E-2</c:v>
                  </c:pt>
                </c:numCache>
              </c:numRef>
            </c:plus>
            <c:minus>
              <c:numRef>
                <c:f>(Feuil1!$H$9;Feuil1!$J$9)</c:f>
                <c:numCache>
                  <c:formatCode>General</c:formatCode>
                  <c:ptCount val="2"/>
                  <c:pt idx="0">
                    <c:v>5.4360457946143512E-2</c:v>
                  </c:pt>
                  <c:pt idx="1">
                    <c:v>4.2853998511138996E-2</c:v>
                  </c:pt>
                </c:numCache>
              </c:numRef>
            </c:minus>
          </c:errBars>
          <c:cat>
            <c:strRef>
              <c:f>(Feuil1!$G$7;Feuil1!$I$7)</c:f>
              <c:strCache>
                <c:ptCount val="2"/>
                <c:pt idx="0">
                  <c:v>post prandial</c:v>
                </c:pt>
                <c:pt idx="1">
                  <c:v>6-hours fasting</c:v>
                </c:pt>
              </c:strCache>
            </c:strRef>
          </c:cat>
          <c:val>
            <c:numRef>
              <c:f>(Feuil1!$G$9;Feuil1!$I$9)</c:f>
              <c:numCache>
                <c:formatCode>General</c:formatCode>
                <c:ptCount val="2"/>
                <c:pt idx="0">
                  <c:v>1.7021474811129766</c:v>
                </c:pt>
                <c:pt idx="1">
                  <c:v>1.5223218554983182</c:v>
                </c:pt>
              </c:numCache>
            </c:numRef>
          </c:val>
        </c:ser>
        <c:ser>
          <c:idx val="1"/>
          <c:order val="1"/>
          <c:tx>
            <c:strRef>
              <c:f>Feuil1!$F$10</c:f>
              <c:strCache>
                <c:ptCount val="1"/>
                <c:pt idx="0">
                  <c:v>ARA diet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(Feuil1!$H$10;Feuil1!$J$10)</c:f>
                <c:numCache>
                  <c:formatCode>General</c:formatCode>
                  <c:ptCount val="2"/>
                  <c:pt idx="0">
                    <c:v>5.0931475885101135E-2</c:v>
                  </c:pt>
                  <c:pt idx="1">
                    <c:v>6.81359768256323E-2</c:v>
                  </c:pt>
                </c:numCache>
              </c:numRef>
            </c:plus>
            <c:minus>
              <c:numRef>
                <c:f>(Feuil1!$H$10;Feuil1!$J$10)</c:f>
                <c:numCache>
                  <c:formatCode>General</c:formatCode>
                  <c:ptCount val="2"/>
                  <c:pt idx="0">
                    <c:v>5.0931475885101135E-2</c:v>
                  </c:pt>
                  <c:pt idx="1">
                    <c:v>6.81359768256323E-2</c:v>
                  </c:pt>
                </c:numCache>
              </c:numRef>
            </c:minus>
          </c:errBars>
          <c:cat>
            <c:strRef>
              <c:f>(Feuil1!$G$7;Feuil1!$I$7)</c:f>
              <c:strCache>
                <c:ptCount val="2"/>
                <c:pt idx="0">
                  <c:v>post prandial</c:v>
                </c:pt>
                <c:pt idx="1">
                  <c:v>6-hours fasting</c:v>
                </c:pt>
              </c:strCache>
            </c:strRef>
          </c:cat>
          <c:val>
            <c:numRef>
              <c:f>(Feuil1!$G$10;Feuil1!$I$10)</c:f>
              <c:numCache>
                <c:formatCode>General</c:formatCode>
                <c:ptCount val="2"/>
                <c:pt idx="0">
                  <c:v>1.8174004065866709</c:v>
                </c:pt>
                <c:pt idx="1">
                  <c:v>1.58538791344884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9"/>
        <c:overlap val="-25"/>
        <c:axId val="178137344"/>
        <c:axId val="178282496"/>
      </c:barChart>
      <c:catAx>
        <c:axId val="1781373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4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78282496"/>
        <c:crosses val="autoZero"/>
        <c:auto val="1"/>
        <c:lblAlgn val="ctr"/>
        <c:lblOffset val="100"/>
        <c:noMultiLvlLbl val="0"/>
      </c:catAx>
      <c:valAx>
        <c:axId val="17828249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>
                    <a:latin typeface="Arial" pitchFamily="34" charset="0"/>
                    <a:cs typeface="Arial" pitchFamily="34" charset="0"/>
                  </a:defRPr>
                </a:pPr>
                <a:r>
                  <a:rPr lang="en-US" sz="1600">
                    <a:latin typeface="Arial" pitchFamily="34" charset="0"/>
                    <a:cs typeface="Arial" pitchFamily="34" charset="0"/>
                  </a:rPr>
                  <a:t>Cholesterolemia (g/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fr-FR"/>
          </a:p>
        </c:txPr>
        <c:crossAx val="178137344"/>
        <c:crosses val="autoZero"/>
        <c:crossBetween val="between"/>
        <c:majorUnit val="0.5"/>
      </c:valAx>
    </c:plotArea>
    <c:legend>
      <c:legendPos val="r"/>
      <c:layout>
        <c:manualLayout>
          <c:xMode val="edge"/>
          <c:yMode val="edge"/>
          <c:x val="0.51598054386028036"/>
          <c:y val="5.6169376242145908E-2"/>
          <c:w val="0.15077908524955919"/>
          <c:h val="8.4201138145144364E-2"/>
        </c:manualLayout>
      </c:layout>
      <c:overlay val="0"/>
      <c:txPr>
        <a:bodyPr/>
        <a:lstStyle/>
        <a:p>
          <a:pPr>
            <a:defRPr sz="1400" b="1">
              <a:latin typeface="Arial" pitchFamily="34" charset="0"/>
              <a:cs typeface="Arial" pitchFamily="34" charset="0"/>
            </a:defRPr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6333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9414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8948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5364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612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658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8341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9561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4987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4921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967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9B7D2-1C25-45FF-8080-D25DBAD08511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45BEF-E85C-4FE6-8CBF-A931C51A51B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2737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0817682"/>
              </p:ext>
            </p:extLst>
          </p:nvPr>
        </p:nvGraphicFramePr>
        <p:xfrm>
          <a:off x="0" y="2483768"/>
          <a:ext cx="6669360" cy="58326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0" y="0"/>
            <a:ext cx="33829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dditional</a:t>
            </a:r>
            <a:r>
              <a:rPr lang="fr-FR" sz="1200" dirty="0" smtClean="0"/>
              <a:t> File 2, Thomas MH </a:t>
            </a:r>
            <a:r>
              <a:rPr lang="fr-FR" sz="1200" i="1" dirty="0" smtClean="0"/>
              <a:t>et al.</a:t>
            </a:r>
            <a:r>
              <a:rPr lang="fr-FR" sz="1200" dirty="0" smtClean="0"/>
              <a:t>, </a:t>
            </a:r>
            <a:r>
              <a:rPr lang="fr-FR" sz="1200" dirty="0" err="1" smtClean="0"/>
              <a:t>revised</a:t>
            </a:r>
            <a:r>
              <a:rPr lang="fr-FR" sz="1200" dirty="0" smtClean="0"/>
              <a:t> version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45535444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15</Words>
  <Application>Microsoft Office PowerPoint</Application>
  <PresentationFormat>Affichage à l'écra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HU de Nanc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OLIVIER Jean-luc</dc:creator>
  <cp:lastModifiedBy>Jean Luc OLIVIER</cp:lastModifiedBy>
  <cp:revision>7</cp:revision>
  <dcterms:created xsi:type="dcterms:W3CDTF">2016-08-08T13:41:00Z</dcterms:created>
  <dcterms:modified xsi:type="dcterms:W3CDTF">2017-07-28T18:33:39Z</dcterms:modified>
</cp:coreProperties>
</file>